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ACFD54E-EB6C-174E-77D8-828E2A4F4C4B}" v="2" dt="2021-04-29T02:53:59.08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53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Inoka Hettiarachchige (DJPR)" userId="72e268ac-d0c6-4335-bfc6-e8215c497fdd" providerId="ADAL" clId="{4771A0DC-9A9D-4693-A0E8-39365BE5575E}"/>
    <pc:docChg chg="modSld">
      <pc:chgData name="Inoka Hettiarachchige (DJPR)" userId="72e268ac-d0c6-4335-bfc6-e8215c497fdd" providerId="ADAL" clId="{4771A0DC-9A9D-4693-A0E8-39365BE5575E}" dt="2021-03-27T09:18:18.368" v="1" actId="113"/>
      <pc:docMkLst>
        <pc:docMk/>
      </pc:docMkLst>
      <pc:sldChg chg="modSp mod">
        <pc:chgData name="Inoka Hettiarachchige (DJPR)" userId="72e268ac-d0c6-4335-bfc6-e8215c497fdd" providerId="ADAL" clId="{4771A0DC-9A9D-4693-A0E8-39365BE5575E}" dt="2021-03-27T09:18:18.368" v="1" actId="113"/>
        <pc:sldMkLst>
          <pc:docMk/>
          <pc:sldMk cId="1354744793" sldId="256"/>
        </pc:sldMkLst>
        <pc:spChg chg="mod">
          <ac:chgData name="Inoka Hettiarachchige (DJPR)" userId="72e268ac-d0c6-4335-bfc6-e8215c497fdd" providerId="ADAL" clId="{4771A0DC-9A9D-4693-A0E8-39365BE5575E}" dt="2021-03-27T09:18:18.368" v="1" actId="113"/>
          <ac:spMkLst>
            <pc:docMk/>
            <pc:sldMk cId="1354744793" sldId="256"/>
            <ac:spMk id="11" creationId="{4BE5AE71-4CF5-4229-BCF1-3A0121421179}"/>
          </ac:spMkLst>
        </pc:spChg>
      </pc:sldChg>
    </pc:docChg>
  </pc:docChgLst>
  <pc:docChgLst>
    <pc:chgData name="Inoka Hettiarachchige (DJPR)" userId="72e268ac-d0c6-4335-bfc6-e8215c497fdd" providerId="ADAL" clId="{7D7E0BC5-84CC-46E2-A185-BD782A912AB1}"/>
    <pc:docChg chg="modSld">
      <pc:chgData name="Inoka Hettiarachchige (DJPR)" userId="72e268ac-d0c6-4335-bfc6-e8215c497fdd" providerId="ADAL" clId="{7D7E0BC5-84CC-46E2-A185-BD782A912AB1}" dt="2021-04-29T10:30:04.809" v="5" actId="1076"/>
      <pc:docMkLst>
        <pc:docMk/>
      </pc:docMkLst>
      <pc:sldChg chg="modSp mod">
        <pc:chgData name="Inoka Hettiarachchige (DJPR)" userId="72e268ac-d0c6-4335-bfc6-e8215c497fdd" providerId="ADAL" clId="{7D7E0BC5-84CC-46E2-A185-BD782A912AB1}" dt="2021-04-29T10:30:04.809" v="5" actId="1076"/>
        <pc:sldMkLst>
          <pc:docMk/>
          <pc:sldMk cId="1354744793" sldId="256"/>
        </pc:sldMkLst>
        <pc:spChg chg="mod">
          <ac:chgData name="Inoka Hettiarachchige (DJPR)" userId="72e268ac-d0c6-4335-bfc6-e8215c497fdd" providerId="ADAL" clId="{7D7E0BC5-84CC-46E2-A185-BD782A912AB1}" dt="2021-04-29T10:30:04.809" v="5" actId="1076"/>
          <ac:spMkLst>
            <pc:docMk/>
            <pc:sldMk cId="1354744793" sldId="256"/>
            <ac:spMk id="11" creationId="{4BE5AE71-4CF5-4229-BCF1-3A0121421179}"/>
          </ac:spMkLst>
        </pc:spChg>
      </pc:sldChg>
    </pc:docChg>
  </pc:docChgLst>
  <pc:docChgLst>
    <pc:chgData name="Kathryn M Guthridge (DJPR)" userId="S::kathryn.guthridge@agriculture.vic.gov.au::985e3336-125c-464e-a99e-9bd7c6ecab71" providerId="AD" clId="Web-{DACFD54E-EB6C-174E-77D8-828E2A4F4C4B}"/>
    <pc:docChg chg="modSld">
      <pc:chgData name="Kathryn M Guthridge (DJPR)" userId="S::kathryn.guthridge@agriculture.vic.gov.au::985e3336-125c-464e-a99e-9bd7c6ecab71" providerId="AD" clId="Web-{DACFD54E-EB6C-174E-77D8-828E2A4F4C4B}" dt="2021-04-29T02:53:59.086" v="1" actId="1076"/>
      <pc:docMkLst>
        <pc:docMk/>
      </pc:docMkLst>
      <pc:sldChg chg="modSp">
        <pc:chgData name="Kathryn M Guthridge (DJPR)" userId="S::kathryn.guthridge@agriculture.vic.gov.au::985e3336-125c-464e-a99e-9bd7c6ecab71" providerId="AD" clId="Web-{DACFD54E-EB6C-174E-77D8-828E2A4F4C4B}" dt="2021-04-29T02:53:59.086" v="1" actId="1076"/>
        <pc:sldMkLst>
          <pc:docMk/>
          <pc:sldMk cId="1354744793" sldId="256"/>
        </pc:sldMkLst>
        <pc:spChg chg="mod">
          <ac:chgData name="Kathryn M Guthridge (DJPR)" userId="S::kathryn.guthridge@agriculture.vic.gov.au::985e3336-125c-464e-a99e-9bd7c6ecab71" providerId="AD" clId="Web-{DACFD54E-EB6C-174E-77D8-828E2A4F4C4B}" dt="2021-04-29T02:53:59.086" v="1" actId="1076"/>
          <ac:spMkLst>
            <pc:docMk/>
            <pc:sldMk cId="1354744793" sldId="256"/>
            <ac:spMk id="11" creationId="{4BE5AE71-4CF5-4229-BCF1-3A0121421179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AEAEED-A528-4236-8514-3621DCF628E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CBD1B66-6CE1-4450-9EE4-A43539F978D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A6E7EA-3BF6-46F0-A584-9B49E731BB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97FD4-2592-4DD5-A94F-37D91660117D}" type="datetimeFigureOut">
              <a:rPr lang="en-AU" smtClean="0"/>
              <a:t>29/04/2021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1B4AE9-A6E0-4993-94B0-5CF01BFDC6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29189C-2EB5-4286-8179-BE92CA2D9F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14C7A-019A-44E3-A2A3-8A39E4EE2E7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248385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110741-E436-42B4-BEEC-8896255D2A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7F9D013-5176-4315-B519-4A81F0CD03E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96CAD68-4F4C-4C42-AF74-42834D2EC3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97FD4-2592-4DD5-A94F-37D91660117D}" type="datetimeFigureOut">
              <a:rPr lang="en-AU" smtClean="0"/>
              <a:t>29/04/2021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9BA1B05-1C4C-48BE-920F-A50954938C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38ACE7-67EF-4AC8-897A-7D86583280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14C7A-019A-44E3-A2A3-8A39E4EE2E7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365559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3EAD669-B158-49C5-87D3-26341D76524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4ECABE2-A1F1-4B68-A9F0-DB360DA7053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268C72C-AC93-4A48-BE65-EFA30B0246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97FD4-2592-4DD5-A94F-37D91660117D}" type="datetimeFigureOut">
              <a:rPr lang="en-AU" smtClean="0"/>
              <a:t>29/04/2021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447E99-7AE6-4C87-8730-39854D3579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58439E-6CB1-4EBE-A919-5ED3766FCB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14C7A-019A-44E3-A2A3-8A39E4EE2E7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474554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5D0D2C-1DB9-4659-B42C-7CFA9B9821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806B120-8572-4E69-9627-F9DD90FAE04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86F7E9-F826-4482-9D43-91FCA28447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97FD4-2592-4DD5-A94F-37D91660117D}" type="datetimeFigureOut">
              <a:rPr lang="en-AU" smtClean="0"/>
              <a:t>29/04/2021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2B2C7F-D508-4133-810D-99B9F4057F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C10F19-B675-426B-AEE7-0EA91D1D2D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14C7A-019A-44E3-A2A3-8A39E4EE2E7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318479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3F1AC3-4267-4656-85DD-8206EB9B0C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E08C42C-5272-43AB-B038-D41AAAF34A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2F8375-826F-4E88-B8BB-BBF60C84C3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97FD4-2592-4DD5-A94F-37D91660117D}" type="datetimeFigureOut">
              <a:rPr lang="en-AU" smtClean="0"/>
              <a:t>29/04/2021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F22058-6D0E-49B1-A633-DF1D209F03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F42222-A1D6-4628-B1AB-460DC0871E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14C7A-019A-44E3-A2A3-8A39E4EE2E7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271934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A86091-2855-4238-9410-1DB4E7D1D2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D668CBE-D60E-4E3E-B6F1-C3E7B7C98A7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6B99F98-C7A9-4C03-8C10-A8B14F61DDD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D82A270-417C-417B-8A67-DA9E5CF80E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97FD4-2592-4DD5-A94F-37D91660117D}" type="datetimeFigureOut">
              <a:rPr lang="en-AU" smtClean="0"/>
              <a:t>29/04/2021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FB5AA1C-A089-4540-98EA-8F2523B5B6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1C4AE4A-60DA-4238-BD53-5B05671FB7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14C7A-019A-44E3-A2A3-8A39E4EE2E7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979591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2E74B3-DC1B-46AC-8E4E-E9DA293C63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E492817-FCA2-45E6-AA87-54B6C4613BA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21D67F0-7A82-41D6-B2EE-F17976CD82D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8148A51-1107-4BEE-8168-9895289113A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0741FCA-30E4-43AD-9C54-3EECC29A9F7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C7E7A59-0C36-4FE7-83D8-3614BDB263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97FD4-2592-4DD5-A94F-37D91660117D}" type="datetimeFigureOut">
              <a:rPr lang="en-AU" smtClean="0"/>
              <a:t>29/04/2021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31C3249-6F1F-48A9-9EE1-9E22DE0DCE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41EAF8C-D178-4D9D-8BA5-0E3FD62C4D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14C7A-019A-44E3-A2A3-8A39E4EE2E7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08764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D0F444-DE4F-44FB-A0B7-ED818133A5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292A1A8-AAE5-4D95-AF8B-97C738BDEA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97FD4-2592-4DD5-A94F-37D91660117D}" type="datetimeFigureOut">
              <a:rPr lang="en-AU" smtClean="0"/>
              <a:t>29/04/2021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C8DE9C2-2EDD-42BB-972D-4BE9BB93F8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11DCE1B-B44C-470C-AFC7-18BE2CD94B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14C7A-019A-44E3-A2A3-8A39E4EE2E7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878921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CE37706-2200-4E97-AE5E-A40C79CAD7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97FD4-2592-4DD5-A94F-37D91660117D}" type="datetimeFigureOut">
              <a:rPr lang="en-AU" smtClean="0"/>
              <a:t>29/04/2021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FAC01E7-CC5E-40C0-BB9E-D5A63A1021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FB17FD8-D29B-4C4C-BA4B-0966D13CCE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14C7A-019A-44E3-A2A3-8A39E4EE2E7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043757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F16EC1-1DE7-4B98-853B-EFF4CD78EB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9E4774B-C2BE-4000-B176-5BC483A4F8E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555A2FF-F62C-45C7-BF22-470275C9AEF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BB7245A-E1FF-4B25-881A-DF76541DC1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97FD4-2592-4DD5-A94F-37D91660117D}" type="datetimeFigureOut">
              <a:rPr lang="en-AU" smtClean="0"/>
              <a:t>29/04/2021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E6519D9-3171-4829-9370-C2DC757A04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ADAEFE7-35DC-431F-9C2F-05F76ED11E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14C7A-019A-44E3-A2A3-8A39E4EE2E7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804309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0112B6-8A34-4B1F-9FB3-671A48483D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8ADDA76-2D0D-4079-BA67-1D50D6CCD44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F9634E9-C598-4EAF-B185-BB28955B799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C49F51B-0CF4-421C-A240-1662CEFC1E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497FD4-2592-4DD5-A94F-37D91660117D}" type="datetimeFigureOut">
              <a:rPr lang="en-AU" smtClean="0"/>
              <a:t>29/04/2021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3276065-2267-4959-9E21-2A22947843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D536B39-7DA9-4242-B0DC-E5E076746C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F14C7A-019A-44E3-A2A3-8A39E4EE2E7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269292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C175E79-2A92-4CCC-9C38-B96ED7F313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DAD6A94-C1A4-4A6C-80C7-6CC6324ABA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9C4A54-FDE4-4FFC-96CE-864457CC15F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497FD4-2592-4DD5-A94F-37D91660117D}" type="datetimeFigureOut">
              <a:rPr lang="en-AU" smtClean="0"/>
              <a:t>29/04/2021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888852-ECCF-4DC5-94AF-87B22ED4692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A645EA-9354-47C3-B279-F2DB708231E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F14C7A-019A-44E3-A2A3-8A39E4EE2E7A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926535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007A2704-89C8-45E9-A8B6-20657989A663}"/>
              </a:ext>
            </a:extLst>
          </p:cNvPr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8288099" y="509768"/>
            <a:ext cx="3764272" cy="244800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3451F91C-F7CD-497A-AD5F-D0D973E576D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861"/>
          <a:stretch/>
        </p:blipFill>
        <p:spPr>
          <a:xfrm>
            <a:off x="114689" y="459237"/>
            <a:ext cx="3766647" cy="2500467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96DF7FFA-0A46-4DA3-9859-A26C9569692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215052" y="444052"/>
            <a:ext cx="3714389" cy="2490738"/>
          </a:xfrm>
          <a:prstGeom prst="rect">
            <a:avLst/>
          </a:prstGeom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34C56AD7-4773-402E-85B2-DD3AB8492920}"/>
              </a:ext>
            </a:extLst>
          </p:cNvPr>
          <p:cNvSpPr/>
          <p:nvPr/>
        </p:nvSpPr>
        <p:spPr>
          <a:xfrm>
            <a:off x="67184" y="476655"/>
            <a:ext cx="3814151" cy="249109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7F9383E5-2108-47CC-A2AA-9228207FD7DB}"/>
              </a:ext>
            </a:extLst>
          </p:cNvPr>
          <p:cNvSpPr/>
          <p:nvPr/>
        </p:nvSpPr>
        <p:spPr>
          <a:xfrm>
            <a:off x="4165171" y="476654"/>
            <a:ext cx="3814151" cy="249073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DB3FBAB3-CE58-4577-A675-F4EB19E12212}"/>
              </a:ext>
            </a:extLst>
          </p:cNvPr>
          <p:cNvSpPr/>
          <p:nvPr/>
        </p:nvSpPr>
        <p:spPr>
          <a:xfrm>
            <a:off x="8263160" y="486383"/>
            <a:ext cx="3814151" cy="2490739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4BE5AE71-4CF5-4229-BCF1-3A0121421179}"/>
              </a:ext>
            </a:extLst>
          </p:cNvPr>
          <p:cNvSpPr/>
          <p:nvPr/>
        </p:nvSpPr>
        <p:spPr>
          <a:xfrm>
            <a:off x="1084278" y="3152001"/>
            <a:ext cx="1035290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AU" sz="1200" b="1" dirty="0">
                <a:solidFill>
                  <a:srgbClr val="202020"/>
                </a:solidFill>
                <a:latin typeface="Palatino Linotype" panose="02040502050505030304" pitchFamily="18" charset="0"/>
                <a:cs typeface="Calibri" panose="020F0502020204030204" pitchFamily="34" charset="0"/>
              </a:rPr>
              <a:t>Figure S4</a:t>
            </a:r>
            <a:r>
              <a:rPr lang="en-AU" sz="1200" dirty="0">
                <a:solidFill>
                  <a:srgbClr val="202020"/>
                </a:solidFill>
                <a:latin typeface="Palatino Linotype" panose="02040502050505030304" pitchFamily="18" charset="0"/>
                <a:cs typeface="Calibri" panose="020F0502020204030204" pitchFamily="34" charset="0"/>
              </a:rPr>
              <a:t>: Clustering analysis of DEGs during early stages of </a:t>
            </a:r>
            <a:r>
              <a:rPr lang="en-AU" sz="1200" dirty="0" err="1">
                <a:solidFill>
                  <a:srgbClr val="202020"/>
                </a:solidFill>
                <a:latin typeface="Palatino Linotype" panose="02040502050505030304" pitchFamily="18" charset="0"/>
                <a:cs typeface="Calibri" panose="020F0502020204030204" pitchFamily="34" charset="0"/>
              </a:rPr>
              <a:t>symbiotum</a:t>
            </a:r>
            <a:r>
              <a:rPr lang="en-AU" sz="1200" dirty="0">
                <a:solidFill>
                  <a:srgbClr val="202020"/>
                </a:solidFill>
                <a:latin typeface="Palatino Linotype" panose="02040502050505030304" pitchFamily="18" charset="0"/>
                <a:cs typeface="Calibri" panose="020F0502020204030204" pitchFamily="34" charset="0"/>
              </a:rPr>
              <a:t> establishment determined by </a:t>
            </a:r>
            <a:r>
              <a:rPr lang="en-AU" sz="1200" dirty="0" err="1">
                <a:solidFill>
                  <a:srgbClr val="202020"/>
                </a:solidFill>
                <a:latin typeface="Palatino Linotype" panose="02040502050505030304" pitchFamily="18" charset="0"/>
                <a:cs typeface="Calibri" panose="020F0502020204030204" pitchFamily="34" charset="0"/>
              </a:rPr>
              <a:t>Mfuzz</a:t>
            </a:r>
            <a:r>
              <a:rPr lang="en-AU" sz="1200" dirty="0">
                <a:solidFill>
                  <a:srgbClr val="202020"/>
                </a:solidFill>
                <a:latin typeface="Palatino Linotype" panose="02040502050505030304" pitchFamily="18" charset="0"/>
                <a:cs typeface="Calibri" panose="020F0502020204030204" pitchFamily="34" charset="0"/>
              </a:rPr>
              <a:t> for (A) SE, (B) NEA11 and (C) NEA12.</a:t>
            </a:r>
            <a:endParaRPr lang="en-AU" sz="1200" dirty="0">
              <a:latin typeface="Palatino Linotype" panose="02040502050505030304" pitchFamily="18" charset="0"/>
              <a:cs typeface="Calibri" panose="020F050202020403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4287EA5-4E05-481B-AAFF-B0E6441639CF}"/>
              </a:ext>
            </a:extLst>
          </p:cNvPr>
          <p:cNvSpPr txBox="1"/>
          <p:nvPr/>
        </p:nvSpPr>
        <p:spPr>
          <a:xfrm>
            <a:off x="40547" y="443701"/>
            <a:ext cx="2148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>
                <a:latin typeface="Palatino Linotype" panose="02040502050505030304" pitchFamily="18" charset="0"/>
              </a:rPr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EF1954C-B04B-4052-9937-80B8044382F7}"/>
              </a:ext>
            </a:extLst>
          </p:cNvPr>
          <p:cNvSpPr txBox="1"/>
          <p:nvPr/>
        </p:nvSpPr>
        <p:spPr>
          <a:xfrm>
            <a:off x="4123980" y="445330"/>
            <a:ext cx="2148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>
                <a:latin typeface="Palatino Linotype" panose="02040502050505030304" pitchFamily="18" charset="0"/>
              </a:rPr>
              <a:t>B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EE75426-ED1A-4482-8D15-BE0297536484}"/>
              </a:ext>
            </a:extLst>
          </p:cNvPr>
          <p:cNvSpPr txBox="1"/>
          <p:nvPr/>
        </p:nvSpPr>
        <p:spPr>
          <a:xfrm>
            <a:off x="8221517" y="443702"/>
            <a:ext cx="2148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dirty="0">
                <a:latin typeface="Palatino Linotype" panose="02040502050505030304" pitchFamily="18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3547447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855</TotalTime>
  <Words>35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noka Hettiarachchige (DJPR)</dc:creator>
  <cp:lastModifiedBy>Inoka Hettiarachchige (DJPR)</cp:lastModifiedBy>
  <cp:revision>14</cp:revision>
  <dcterms:created xsi:type="dcterms:W3CDTF">2020-06-05T01:17:08Z</dcterms:created>
  <dcterms:modified xsi:type="dcterms:W3CDTF">2021-04-29T10:30:10Z</dcterms:modified>
</cp:coreProperties>
</file>